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5" r:id="rId2"/>
    <p:sldId id="270" r:id="rId3"/>
    <p:sldId id="266" r:id="rId4"/>
  </p:sldIdLst>
  <p:sldSz cx="6858000" cy="9144000" type="screen4x3"/>
  <p:notesSz cx="6805613" cy="99441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11785" autoAdjust="0"/>
    <p:restoredTop sz="94660"/>
  </p:normalViewPr>
  <p:slideViewPr>
    <p:cSldViewPr>
      <p:cViewPr>
        <p:scale>
          <a:sx n="100" d="100"/>
          <a:sy n="100" d="100"/>
        </p:scale>
        <p:origin x="612" y="-293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099" cy="497205"/>
          </a:xfrm>
          <a:prstGeom prst="rect">
            <a:avLst/>
          </a:prstGeom>
        </p:spPr>
        <p:txBody>
          <a:bodyPr vert="horz" lIns="92583" tIns="46292" rIns="92583" bIns="46292" rtlCol="0"/>
          <a:lstStyle>
            <a:lvl1pPr algn="l">
              <a:defRPr sz="1200"/>
            </a:lvl1pPr>
          </a:lstStyle>
          <a:p>
            <a:endParaRPr lang="de-CH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4939" y="0"/>
            <a:ext cx="2949099" cy="497205"/>
          </a:xfrm>
          <a:prstGeom prst="rect">
            <a:avLst/>
          </a:prstGeom>
        </p:spPr>
        <p:txBody>
          <a:bodyPr vert="horz" lIns="92583" tIns="46292" rIns="92583" bIns="46292" rtlCol="0"/>
          <a:lstStyle>
            <a:lvl1pPr algn="r">
              <a:defRPr sz="1200"/>
            </a:lvl1pPr>
          </a:lstStyle>
          <a:p>
            <a:fld id="{2A294945-50DE-4864-BEA7-EFEE083E998B}" type="datetimeFigureOut">
              <a:rPr lang="de-CH" smtClean="0"/>
              <a:t>28.12.2020</a:t>
            </a:fld>
            <a:endParaRPr lang="de-CH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8763" cy="3730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583" tIns="46292" rIns="92583" bIns="46292" rtlCol="0" anchor="ctr"/>
          <a:lstStyle/>
          <a:p>
            <a:endParaRPr lang="de-CH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0562" y="4723447"/>
            <a:ext cx="5444490" cy="4474845"/>
          </a:xfrm>
          <a:prstGeom prst="rect">
            <a:avLst/>
          </a:prstGeom>
        </p:spPr>
        <p:txBody>
          <a:bodyPr vert="horz" lIns="92583" tIns="46292" rIns="92583" bIns="46292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45169"/>
            <a:ext cx="2949099" cy="497205"/>
          </a:xfrm>
          <a:prstGeom prst="rect">
            <a:avLst/>
          </a:prstGeom>
        </p:spPr>
        <p:txBody>
          <a:bodyPr vert="horz" lIns="92583" tIns="46292" rIns="92583" bIns="46292" rtlCol="0" anchor="b"/>
          <a:lstStyle>
            <a:lvl1pPr algn="l">
              <a:defRPr sz="1200"/>
            </a:lvl1pPr>
          </a:lstStyle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4939" y="9445169"/>
            <a:ext cx="2949099" cy="497205"/>
          </a:xfrm>
          <a:prstGeom prst="rect">
            <a:avLst/>
          </a:prstGeom>
        </p:spPr>
        <p:txBody>
          <a:bodyPr vert="horz" lIns="92583" tIns="46292" rIns="92583" bIns="46292" rtlCol="0" anchor="b"/>
          <a:lstStyle>
            <a:lvl1pPr algn="r">
              <a:defRPr sz="1200"/>
            </a:lvl1pPr>
          </a:lstStyle>
          <a:p>
            <a:fld id="{EFC58FD4-4FEF-4DCF-86F3-F51BAFEEE056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7629084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1276B-6FB1-4E58-ACA9-87920A697F16}" type="datetimeFigureOut">
              <a:rPr lang="de-CH" smtClean="0"/>
              <a:t>28.12.2020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AB827-6647-480A-B786-9E5431ADAABD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8583296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1276B-6FB1-4E58-ACA9-87920A697F16}" type="datetimeFigureOut">
              <a:rPr lang="de-CH" smtClean="0"/>
              <a:t>28.12.2020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AB827-6647-480A-B786-9E5431ADAABD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7713134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1276B-6FB1-4E58-ACA9-87920A697F16}" type="datetimeFigureOut">
              <a:rPr lang="de-CH" smtClean="0"/>
              <a:t>28.12.2020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AB827-6647-480A-B786-9E5431ADAABD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3326920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1276B-6FB1-4E58-ACA9-87920A697F16}" type="datetimeFigureOut">
              <a:rPr lang="de-CH" smtClean="0"/>
              <a:t>28.12.2020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AB827-6647-480A-B786-9E5431ADAABD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6496249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1276B-6FB1-4E58-ACA9-87920A697F16}" type="datetimeFigureOut">
              <a:rPr lang="de-CH" smtClean="0"/>
              <a:t>28.12.2020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AB827-6647-480A-B786-9E5431ADAABD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2734440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1276B-6FB1-4E58-ACA9-87920A697F16}" type="datetimeFigureOut">
              <a:rPr lang="de-CH" smtClean="0"/>
              <a:t>28.12.2020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AB827-6647-480A-B786-9E5431ADAABD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1902874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1276B-6FB1-4E58-ACA9-87920A697F16}" type="datetimeFigureOut">
              <a:rPr lang="de-CH" smtClean="0"/>
              <a:t>28.12.2020</a:t>
            </a:fld>
            <a:endParaRPr lang="de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AB827-6647-480A-B786-9E5431ADAABD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4448162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1276B-6FB1-4E58-ACA9-87920A697F16}" type="datetimeFigureOut">
              <a:rPr lang="de-CH" smtClean="0"/>
              <a:t>28.12.2020</a:t>
            </a:fld>
            <a:endParaRPr lang="de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AB827-6647-480A-B786-9E5431ADAABD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0435009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1276B-6FB1-4E58-ACA9-87920A697F16}" type="datetimeFigureOut">
              <a:rPr lang="de-CH" smtClean="0"/>
              <a:t>28.12.2020</a:t>
            </a:fld>
            <a:endParaRPr lang="de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AB827-6647-480A-B786-9E5431ADAABD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3966625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1276B-6FB1-4E58-ACA9-87920A697F16}" type="datetimeFigureOut">
              <a:rPr lang="de-CH" smtClean="0"/>
              <a:t>28.12.2020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AB827-6647-480A-B786-9E5431ADAABD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6000271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C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51276B-6FB1-4E58-ACA9-87920A697F16}" type="datetimeFigureOut">
              <a:rPr lang="de-CH" smtClean="0"/>
              <a:t>28.12.2020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AB827-6647-480A-B786-9E5431ADAABD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6461086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51276B-6FB1-4E58-ACA9-87920A697F16}" type="datetimeFigureOut">
              <a:rPr lang="de-CH" smtClean="0"/>
              <a:t>28.12.2020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0AB827-6647-480A-B786-9E5431ADAABD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6368384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88640" y="347531"/>
            <a:ext cx="7713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S1</a:t>
            </a:r>
            <a:endParaRPr lang="de-CH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88641" y="347531"/>
            <a:ext cx="7713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S1</a:t>
            </a:r>
            <a:endParaRPr lang="de-CH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Group 6"/>
          <p:cNvGrpSpPr/>
          <p:nvPr/>
        </p:nvGrpSpPr>
        <p:grpSpPr>
          <a:xfrm>
            <a:off x="479425" y="2061326"/>
            <a:ext cx="5905500" cy="4552481"/>
            <a:chOff x="479425" y="2061326"/>
            <a:chExt cx="5905500" cy="4552481"/>
          </a:xfrm>
        </p:grpSpPr>
        <p:pic>
          <p:nvPicPr>
            <p:cNvPr id="8" name="Picture 7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539" b="17740"/>
            <a:stretch/>
          </p:blipFill>
          <p:spPr bwMode="auto">
            <a:xfrm>
              <a:off x="479425" y="2130030"/>
              <a:ext cx="5905500" cy="4176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9" name="CasellaDiTesto 5"/>
            <p:cNvSpPr txBox="1"/>
            <p:nvPr/>
          </p:nvSpPr>
          <p:spPr>
            <a:xfrm>
              <a:off x="2917048" y="6306030"/>
              <a:ext cx="100811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4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ime (</a:t>
              </a:r>
              <a:r>
                <a:rPr lang="it-IT" sz="140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in</a:t>
              </a:r>
              <a:r>
                <a:rPr lang="it-IT" sz="14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10" name="CasellaDiTesto 6"/>
            <p:cNvSpPr txBox="1"/>
            <p:nvPr/>
          </p:nvSpPr>
          <p:spPr>
            <a:xfrm>
              <a:off x="980728" y="2800405"/>
              <a:ext cx="215444" cy="595809"/>
            </a:xfrm>
            <a:prstGeom prst="rect">
              <a:avLst/>
            </a:prstGeom>
            <a:noFill/>
          </p:spPr>
          <p:txBody>
            <a:bodyPr vert="vert270" wrap="square" lIns="0" tIns="0" rIns="0" bIns="0" rtlCol="0">
              <a:spAutoFit/>
            </a:bodyPr>
            <a:lstStyle/>
            <a:p>
              <a:r>
                <a:rPr lang="it-IT" sz="14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-</a:t>
              </a:r>
              <a:r>
                <a:rPr lang="it-IT" sz="140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ha</a:t>
              </a:r>
              <a:r>
                <a:rPr lang="it-IT" sz="1400" i="1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endParaRPr lang="it-IT" sz="14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CasellaDiTesto 7"/>
            <p:cNvSpPr txBox="1"/>
            <p:nvPr/>
          </p:nvSpPr>
          <p:spPr>
            <a:xfrm>
              <a:off x="1700808" y="4533126"/>
              <a:ext cx="430887" cy="595809"/>
            </a:xfrm>
            <a:prstGeom prst="rect">
              <a:avLst/>
            </a:prstGeom>
            <a:noFill/>
          </p:spPr>
          <p:txBody>
            <a:bodyPr vert="vert270" wrap="square" lIns="0" tIns="0" rIns="0" bIns="0" rtlCol="0">
              <a:spAutoFit/>
            </a:bodyPr>
            <a:lstStyle/>
            <a:p>
              <a:r>
                <a:rPr lang="it-IT" sz="14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-Rha</a:t>
              </a:r>
              <a:r>
                <a:rPr lang="it-IT" sz="1400" i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  <a:p>
              <a:endParaRPr lang="it-IT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CasellaDiTesto 8"/>
            <p:cNvSpPr txBox="1"/>
            <p:nvPr/>
          </p:nvSpPr>
          <p:spPr>
            <a:xfrm>
              <a:off x="1726679" y="2204596"/>
              <a:ext cx="430887" cy="595809"/>
            </a:xfrm>
            <a:prstGeom prst="rect">
              <a:avLst/>
            </a:prstGeom>
            <a:noFill/>
          </p:spPr>
          <p:txBody>
            <a:bodyPr vert="vert270" wrap="square" lIns="0" tIns="0" rIns="0" bIns="0" rtlCol="0">
              <a:spAutoFit/>
            </a:bodyPr>
            <a:lstStyle/>
            <a:p>
              <a:r>
                <a:rPr lang="it-IT" sz="14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-Rha</a:t>
              </a:r>
              <a:r>
                <a:rPr lang="it-IT" sz="1400" i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  <a:p>
              <a:endParaRPr lang="it-IT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CasellaDiTesto 9"/>
            <p:cNvSpPr txBox="1"/>
            <p:nvPr/>
          </p:nvSpPr>
          <p:spPr>
            <a:xfrm>
              <a:off x="5849976" y="2359230"/>
              <a:ext cx="215444" cy="960701"/>
            </a:xfrm>
            <a:prstGeom prst="rect">
              <a:avLst/>
            </a:prstGeom>
            <a:noFill/>
          </p:spPr>
          <p:txBody>
            <a:bodyPr vert="vert270" wrap="square" lIns="0" tIns="0" rIns="0" bIns="0" rtlCol="0">
              <a:spAutoFit/>
            </a:bodyPr>
            <a:lstStyle/>
            <a:p>
              <a:r>
                <a:rPr lang="it-IT" sz="14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-GlcNAc</a:t>
              </a:r>
              <a:r>
                <a:rPr lang="it-IT" sz="1400" i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14" name="CasellaDiTesto 10"/>
            <p:cNvSpPr txBox="1"/>
            <p:nvPr/>
          </p:nvSpPr>
          <p:spPr>
            <a:xfrm>
              <a:off x="2537608" y="4516374"/>
              <a:ext cx="215444" cy="777776"/>
            </a:xfrm>
            <a:prstGeom prst="rect">
              <a:avLst/>
            </a:prstGeom>
            <a:noFill/>
          </p:spPr>
          <p:txBody>
            <a:bodyPr vert="vert270" wrap="square" lIns="0" tIns="0" rIns="0" bIns="0" rtlCol="0">
              <a:spAutoFit/>
            </a:bodyPr>
            <a:lstStyle/>
            <a:p>
              <a:r>
                <a:rPr lang="it-IT" sz="14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,3-Rha</a:t>
              </a:r>
              <a:r>
                <a:rPr lang="it-IT" sz="1400" i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15" name="CasellaDiTesto 11"/>
            <p:cNvSpPr txBox="1"/>
            <p:nvPr/>
          </p:nvSpPr>
          <p:spPr>
            <a:xfrm>
              <a:off x="4099718" y="3784675"/>
              <a:ext cx="215444" cy="745367"/>
            </a:xfrm>
            <a:prstGeom prst="rect">
              <a:avLst/>
            </a:prstGeom>
            <a:noFill/>
          </p:spPr>
          <p:txBody>
            <a:bodyPr vert="vert270" wrap="square" lIns="0" tIns="0" rIns="0" bIns="0" rtlCol="0">
              <a:spAutoFit/>
            </a:bodyPr>
            <a:lstStyle/>
            <a:p>
              <a:r>
                <a:rPr lang="it-IT" sz="14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,6-Glc</a:t>
              </a:r>
              <a:r>
                <a:rPr lang="it-IT" sz="1400" i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16" name="CasellaDiTesto 12"/>
            <p:cNvSpPr txBox="1"/>
            <p:nvPr/>
          </p:nvSpPr>
          <p:spPr>
            <a:xfrm>
              <a:off x="2140392" y="2061326"/>
              <a:ext cx="430887" cy="595809"/>
            </a:xfrm>
            <a:prstGeom prst="rect">
              <a:avLst/>
            </a:prstGeom>
            <a:noFill/>
          </p:spPr>
          <p:txBody>
            <a:bodyPr vert="vert270" wrap="square" lIns="0" tIns="0" rIns="0" bIns="0" rtlCol="0">
              <a:spAutoFit/>
            </a:bodyPr>
            <a:lstStyle/>
            <a:p>
              <a:r>
                <a:rPr lang="it-IT" sz="14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-</a:t>
              </a:r>
              <a:r>
                <a:rPr lang="it-IT" sz="140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lc</a:t>
              </a:r>
              <a:r>
                <a:rPr lang="it-IT" sz="1400" i="1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endParaRPr lang="it-IT" sz="140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it-IT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CasellaDiTesto 13"/>
            <p:cNvSpPr txBox="1"/>
            <p:nvPr/>
          </p:nvSpPr>
          <p:spPr>
            <a:xfrm>
              <a:off x="4354644" y="4010832"/>
              <a:ext cx="215444" cy="745367"/>
            </a:xfrm>
            <a:prstGeom prst="rect">
              <a:avLst/>
            </a:prstGeom>
            <a:noFill/>
          </p:spPr>
          <p:txBody>
            <a:bodyPr vert="vert270" wrap="square" lIns="0" tIns="0" rIns="0" bIns="0" rtlCol="0">
              <a:spAutoFit/>
            </a:bodyPr>
            <a:lstStyle/>
            <a:p>
              <a:r>
                <a:rPr lang="it-IT" sz="14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,6-Glc</a:t>
              </a:r>
              <a:r>
                <a:rPr lang="it-IT" sz="1400" i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18" name="CasellaDiTesto 14"/>
            <p:cNvSpPr txBox="1"/>
            <p:nvPr/>
          </p:nvSpPr>
          <p:spPr>
            <a:xfrm>
              <a:off x="4721055" y="2800406"/>
              <a:ext cx="215444" cy="1024280"/>
            </a:xfrm>
            <a:prstGeom prst="rect">
              <a:avLst/>
            </a:prstGeom>
            <a:noFill/>
          </p:spPr>
          <p:txBody>
            <a:bodyPr vert="vert270" wrap="square" lIns="0" tIns="0" rIns="0" bIns="0" rtlCol="0">
              <a:spAutoFit/>
            </a:bodyPr>
            <a:lstStyle/>
            <a:p>
              <a:r>
                <a:rPr lang="it-IT" sz="14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,4,6-Glc</a:t>
              </a:r>
              <a:r>
                <a:rPr lang="it-IT" sz="1400" i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19" name="CasellaDiTesto 15"/>
            <p:cNvSpPr txBox="1"/>
            <p:nvPr/>
          </p:nvSpPr>
          <p:spPr>
            <a:xfrm>
              <a:off x="5201904" y="3559048"/>
              <a:ext cx="215444" cy="372684"/>
            </a:xfrm>
            <a:prstGeom prst="rect">
              <a:avLst/>
            </a:prstGeom>
            <a:noFill/>
          </p:spPr>
          <p:txBody>
            <a:bodyPr vert="vert270" wrap="square" lIns="0" tIns="0" rIns="0" bIns="0" rtlCol="0">
              <a:spAutoFit/>
            </a:bodyPr>
            <a:lstStyle/>
            <a:p>
              <a:r>
                <a:rPr lang="it-IT" sz="14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o</a:t>
              </a:r>
            </a:p>
          </p:txBody>
        </p:sp>
        <p:cxnSp>
          <p:nvCxnSpPr>
            <p:cNvPr id="20" name="Connettore 2 19"/>
            <p:cNvCxnSpPr/>
            <p:nvPr/>
          </p:nvCxnSpPr>
          <p:spPr>
            <a:xfrm flipH="1">
              <a:off x="4315162" y="4790954"/>
              <a:ext cx="147204" cy="385463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Rectangle 1"/>
          <p:cNvSpPr/>
          <p:nvPr/>
        </p:nvSpPr>
        <p:spPr>
          <a:xfrm>
            <a:off x="435768" y="6896383"/>
            <a:ext cx="6089576" cy="6851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0"/>
              </a:spcAft>
            </a:pPr>
            <a:r>
              <a:rPr lang="en-US" sz="120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sz="120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S1</a:t>
            </a:r>
            <a:r>
              <a:rPr lang="en-US" sz="120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LC-FID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 GLC chromatogram of the partially-methylated </a:t>
            </a:r>
            <a:r>
              <a:rPr lang="en-US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lditol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cetate (PMAA) derivatives obtained for linkage analysis of the O25B </a:t>
            </a:r>
            <a:r>
              <a:rPr lang="en-US" sz="1200" dirty="0" err="1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lycopeptide</a:t>
            </a:r>
            <a:endParaRPr lang="de-CH" sz="1200" dirty="0" smtClean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0"/>
              </a:spcAft>
            </a:pP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de-CH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502235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9550" y="1115616"/>
            <a:ext cx="6053826" cy="3312369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378186" y="111561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e-CH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78186" y="277180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de-CH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07254" y="107504"/>
            <a:ext cx="7713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S2</a:t>
            </a:r>
            <a:endParaRPr lang="de-CH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492936" y="4860032"/>
            <a:ext cx="6104416" cy="6851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0"/>
              </a:spcAft>
            </a:pPr>
            <a:r>
              <a:rPr lang="en-GB" sz="120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</a:t>
            </a:r>
            <a:r>
              <a:rPr lang="en-GB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S2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Overlay of the 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1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H NMR spectra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of O25B-EPA conjugate (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A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),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and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O25A-EPA conjugate (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B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).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The spectra were recorded with pre-saturation at 400 MHz at 303 K; diagnostic peaks are labeled.</a:t>
            </a:r>
            <a:r>
              <a:rPr lang="de-CH" sz="1200" dirty="0"/>
              <a:t> </a:t>
            </a:r>
            <a:endParaRPr lang="de-CH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019055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F:\GlycoVaxyn\2015\Ec25B paper\Final\NMR of E coli O25_NR B and W for paper.t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3650" y="611560"/>
            <a:ext cx="6634349" cy="497576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661265" y="97159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de-CH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680202" y="341987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de-CH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52835" y="35496"/>
            <a:ext cx="7713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S3</a:t>
            </a:r>
            <a:endParaRPr lang="de-CH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552492" y="5587322"/>
            <a:ext cx="5976664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endParaRPr lang="de-CH" sz="1200" dirty="0"/>
          </a:p>
          <a:p>
            <a:pPr>
              <a:spcAft>
                <a:spcPts val="0"/>
              </a:spcAft>
            </a:pPr>
            <a:r>
              <a:rPr lang="de-CH" sz="1200" b="1" dirty="0" smtClean="0"/>
              <a:t>Fig. S3 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Expansions of the 2D </a:t>
            </a:r>
            <a:r>
              <a:rPr lang="en-GB" sz="12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1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H-</a:t>
            </a:r>
            <a:r>
              <a:rPr lang="en-GB" sz="12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1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H correlation spectra: </a:t>
            </a: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A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O25B-GP (</a:t>
            </a:r>
            <a:r>
              <a:rPr lang="en-GB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NaOD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) and </a:t>
            </a: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B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O25B-GP. In </a:t>
            </a: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A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, the COSY (red)/TOCSY (black) overlay of O25B-GP (</a:t>
            </a:r>
            <a:r>
              <a:rPr lang="en-GB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NaOD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) shows the </a:t>
            </a:r>
            <a:r>
              <a:rPr lang="en-GB" sz="1200" dirty="0">
                <a:latin typeface="Symbol" panose="05050102010706020507" pitchFamily="18" charset="2"/>
                <a:ea typeface="Calibri" panose="020F0502020204030204" pitchFamily="34" charset="0"/>
                <a:cs typeface="Calibri" panose="020F0502020204030204" pitchFamily="34" charset="0"/>
              </a:rPr>
              <a:t>a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-</a:t>
            </a:r>
            <a:r>
              <a:rPr lang="en-GB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Rha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correlations from H-6 to H-2 for terminal </a:t>
            </a:r>
            <a:r>
              <a:rPr lang="en-GB" sz="1200" dirty="0">
                <a:latin typeface="Symbol" panose="05050102010706020507" pitchFamily="18" charset="2"/>
                <a:ea typeface="Calibri" panose="020F0502020204030204" pitchFamily="34" charset="0"/>
                <a:cs typeface="Calibri" panose="020F0502020204030204" pitchFamily="34" charset="0"/>
              </a:rPr>
              <a:t>a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-</a:t>
            </a:r>
            <a:r>
              <a:rPr lang="en-GB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Rha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(H-6 at 1.31 ppm) and 3-linked </a:t>
            </a:r>
            <a:r>
              <a:rPr lang="en-GB" sz="1200" dirty="0">
                <a:latin typeface="Symbol" panose="05050102010706020507" pitchFamily="18" charset="2"/>
                <a:ea typeface="Calibri" panose="020F0502020204030204" pitchFamily="34" charset="0"/>
                <a:cs typeface="Calibri" panose="020F0502020204030204" pitchFamily="34" charset="0"/>
              </a:rPr>
              <a:t>a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-</a:t>
            </a:r>
            <a:r>
              <a:rPr lang="en-GB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Rha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(at 1.24 ppm). The TOCSY spectrum in </a:t>
            </a: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B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shows the correlations from H-6 (at 1.26 ppm) to H-2 (at 5.21 ppm) for 3-linked </a:t>
            </a:r>
            <a:r>
              <a:rPr lang="en-GB" sz="1200" dirty="0">
                <a:latin typeface="Symbol" panose="05050102010706020507" pitchFamily="18" charset="2"/>
                <a:ea typeface="Calibri" panose="020F0502020204030204" pitchFamily="34" charset="0"/>
                <a:cs typeface="Calibri" panose="020F0502020204030204" pitchFamily="34" charset="0"/>
              </a:rPr>
              <a:t>a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-Rha2Ac. The spectra were recorded at 303 K (400 MHz) with a TOCSY mixing time of 120 </a:t>
            </a:r>
            <a:r>
              <a:rPr lang="en-GB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ms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.</a:t>
            </a:r>
            <a:endParaRPr lang="de-CH" sz="14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95213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03</Words>
  <Application>Microsoft Office PowerPoint</Application>
  <PresentationFormat>On-screen Show (4:3)</PresentationFormat>
  <Paragraphs>24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Symbol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 Häuptle</dc:creator>
  <cp:lastModifiedBy>Michael Kowarik</cp:lastModifiedBy>
  <cp:revision>73</cp:revision>
  <cp:lastPrinted>2020-12-24T13:22:48Z</cp:lastPrinted>
  <dcterms:created xsi:type="dcterms:W3CDTF">2015-09-10T07:11:30Z</dcterms:created>
  <dcterms:modified xsi:type="dcterms:W3CDTF">2020-12-28T10:04:02Z</dcterms:modified>
</cp:coreProperties>
</file>